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2D9FCD-DF68-465C-8391-F5D8EFFCC20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0E5A5F-5B7F-44B1-9DDF-F8F4222A548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7D0E01-1756-4EBD-8034-1EA2C59A8B6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7C2921-12BA-47C2-BD60-3A7310BA5A6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B5C78A-17B8-43CF-9591-29DAA540B18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2E6EBD-D42D-40CF-AFCA-708237D8040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E910CA-491E-4854-BF35-11B95FB7BA2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110B17-2F57-45C3-AA45-C99A3E584EF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053D7C-519F-48C9-A29D-FC1BFAABA4E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1D86BA-4E71-4713-8957-D69D0AEFDB6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475A02-FC35-40EA-9C54-701085A2AD5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DC499D-93DF-4DF4-AAEB-6AE145193DB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4ACEA0B-98F3-4D85-8F44-0DEB4F5040DD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2167920" y="1206720"/>
            <a:ext cx="3997800" cy="2010960"/>
            <a:chOff x="2167920" y="1206720"/>
            <a:chExt cx="3997800" cy="2010960"/>
          </a:xfrm>
        </p:grpSpPr>
        <p:sp>
          <p:nvSpPr>
            <p:cNvPr id="42" name="Text Box 101"/>
            <p:cNvSpPr/>
            <p:nvPr/>
          </p:nvSpPr>
          <p:spPr>
            <a:xfrm rot="18531600">
              <a:off x="3097440" y="1686960"/>
              <a:ext cx="884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CT116-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Text Box 102"/>
            <p:cNvSpPr/>
            <p:nvPr/>
          </p:nvSpPr>
          <p:spPr>
            <a:xfrm rot="18531600">
              <a:off x="3350160" y="1599840"/>
              <a:ext cx="10965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CT116-SN6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Text Box 103"/>
            <p:cNvSpPr/>
            <p:nvPr/>
          </p:nvSpPr>
          <p:spPr>
            <a:xfrm rot="18531600">
              <a:off x="3701160" y="1643400"/>
              <a:ext cx="994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CT116-A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Text Box 104"/>
            <p:cNvSpPr/>
            <p:nvPr/>
          </p:nvSpPr>
          <p:spPr>
            <a:xfrm rot="18531600">
              <a:off x="4011120" y="1614960"/>
              <a:ext cx="1181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CT116-SN5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Text Box 105"/>
            <p:cNvSpPr/>
            <p:nvPr/>
          </p:nvSpPr>
          <p:spPr>
            <a:xfrm rot="18531600">
              <a:off x="4385160" y="1645200"/>
              <a:ext cx="994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CT116-C8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Text Box 106"/>
            <p:cNvSpPr/>
            <p:nvPr/>
          </p:nvSpPr>
          <p:spPr>
            <a:xfrm rot="18531600">
              <a:off x="4776120" y="1644480"/>
              <a:ext cx="1003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CT116-G7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Text Box 110"/>
            <p:cNvSpPr/>
            <p:nvPr/>
          </p:nvSpPr>
          <p:spPr>
            <a:xfrm>
              <a:off x="2168280" y="2184120"/>
              <a:ext cx="478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200" spc="-1" strike="noStrike">
                  <a:solidFill>
                    <a:srgbClr val="000000"/>
                  </a:solidFill>
                  <a:latin typeface="Arial"/>
                </a:rPr>
                <a:t>PgP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Text Box 323"/>
            <p:cNvSpPr/>
            <p:nvPr/>
          </p:nvSpPr>
          <p:spPr>
            <a:xfrm>
              <a:off x="5370840" y="2171520"/>
              <a:ext cx="794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170 Kda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Text Box 101"/>
            <p:cNvSpPr/>
            <p:nvPr/>
          </p:nvSpPr>
          <p:spPr>
            <a:xfrm rot="18531600">
              <a:off x="2759040" y="1711800"/>
              <a:ext cx="755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MCF7-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51" name=""/>
            <p:cNvGrpSpPr/>
            <p:nvPr/>
          </p:nvGrpSpPr>
          <p:grpSpPr>
            <a:xfrm>
              <a:off x="2743200" y="2171520"/>
              <a:ext cx="2525760" cy="277920"/>
              <a:chOff x="2743200" y="2171520"/>
              <a:chExt cx="2525760" cy="277920"/>
            </a:xfrm>
          </p:grpSpPr>
          <p:pic>
            <p:nvPicPr>
              <p:cNvPr id="52" name="" descr=""/>
              <p:cNvPicPr/>
              <p:nvPr/>
            </p:nvPicPr>
            <p:blipFill>
              <a:blip r:embed="rId1"/>
              <a:stretch/>
            </p:blipFill>
            <p:spPr>
              <a:xfrm>
                <a:off x="2749320" y="2171520"/>
                <a:ext cx="2519640" cy="2714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53" name=""/>
              <p:cNvSpPr/>
              <p:nvPr/>
            </p:nvSpPr>
            <p:spPr>
              <a:xfrm>
                <a:off x="2743200" y="2171520"/>
                <a:ext cx="2520720" cy="27792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54" name=""/>
            <p:cNvGrpSpPr/>
            <p:nvPr/>
          </p:nvGrpSpPr>
          <p:grpSpPr>
            <a:xfrm>
              <a:off x="2741400" y="2544840"/>
              <a:ext cx="2521080" cy="266400"/>
              <a:chOff x="2741400" y="2544840"/>
              <a:chExt cx="2521080" cy="266400"/>
            </a:xfrm>
          </p:grpSpPr>
          <p:pic>
            <p:nvPicPr>
              <p:cNvPr id="55" name="" descr=""/>
              <p:cNvPicPr/>
              <p:nvPr/>
            </p:nvPicPr>
            <p:blipFill>
              <a:blip r:embed="rId2"/>
              <a:stretch/>
            </p:blipFill>
            <p:spPr>
              <a:xfrm>
                <a:off x="2750760" y="2544840"/>
                <a:ext cx="2509920" cy="2664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56" name=""/>
              <p:cNvSpPr/>
              <p:nvPr/>
            </p:nvSpPr>
            <p:spPr>
              <a:xfrm>
                <a:off x="2741400" y="2544840"/>
                <a:ext cx="2521080" cy="26172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57" name=""/>
            <p:cNvGrpSpPr/>
            <p:nvPr/>
          </p:nvGrpSpPr>
          <p:grpSpPr>
            <a:xfrm>
              <a:off x="2735280" y="2955960"/>
              <a:ext cx="2552760" cy="261720"/>
              <a:chOff x="2735280" y="2955960"/>
              <a:chExt cx="2552760" cy="261720"/>
            </a:xfrm>
          </p:grpSpPr>
          <p:pic>
            <p:nvPicPr>
              <p:cNvPr id="58" name="" descr=""/>
              <p:cNvPicPr/>
              <p:nvPr/>
            </p:nvPicPr>
            <p:blipFill>
              <a:blip r:embed="rId3">
                <a:lum bright="14000"/>
              </a:blip>
              <a:stretch/>
            </p:blipFill>
            <p:spPr>
              <a:xfrm>
                <a:off x="2735280" y="2955960"/>
                <a:ext cx="2552760" cy="2617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59" name=""/>
              <p:cNvSpPr/>
              <p:nvPr/>
            </p:nvSpPr>
            <p:spPr>
              <a:xfrm>
                <a:off x="2746080" y="2955960"/>
                <a:ext cx="2533680" cy="24876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60" name="Text Box 323"/>
            <p:cNvSpPr/>
            <p:nvPr/>
          </p:nvSpPr>
          <p:spPr>
            <a:xfrm>
              <a:off x="5369040" y="2531880"/>
              <a:ext cx="794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190 Kda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Text Box 323"/>
            <p:cNvSpPr/>
            <p:nvPr/>
          </p:nvSpPr>
          <p:spPr>
            <a:xfrm>
              <a:off x="5455440" y="2930400"/>
              <a:ext cx="7095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50 Kda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Text Box 110"/>
            <p:cNvSpPr/>
            <p:nvPr/>
          </p:nvSpPr>
          <p:spPr>
            <a:xfrm>
              <a:off x="2167920" y="2544840"/>
              <a:ext cx="6044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MRP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Text Box 110"/>
            <p:cNvSpPr/>
            <p:nvPr/>
          </p:nvSpPr>
          <p:spPr>
            <a:xfrm>
              <a:off x="2169360" y="2930400"/>
              <a:ext cx="459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Tub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4" name=""/>
          <p:cNvSpPr/>
          <p:nvPr/>
        </p:nvSpPr>
        <p:spPr>
          <a:xfrm flipV="1" rot="10800000">
            <a:off x="1023840" y="4436280"/>
            <a:ext cx="7385040" cy="100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Figure S1: Immunodetection of efflux pumps Pgp, MRP1.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The multidrug-resistant doxorubicin-selected MCF7-R breast cancer cell line was used as a positive control for Pgp and MRP1 (7). Proteins from the extracts (10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</a:rPr>
              <a:t>5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cells per lane) were electrophoretically separated on 7.5% SDS-PAGE. Primary antibody used were anti-p-Glycoprotein clone F4 (Neomarkers, Fremont, CA) and anti-MRP1 (Alexis Corp, San Diego, CA). Equal loading is shown by β-tubulin (clone tub2.1, Sigma)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4-08T09:35:14Z</dcterms:created>
  <dc:creator>DEL RIO</dc:creator>
  <dc:description/>
  <dc:language>en-US</dc:language>
  <cp:lastModifiedBy>DEL RIO</cp:lastModifiedBy>
  <dcterms:modified xsi:type="dcterms:W3CDTF">2011-04-29T10:13:10Z</dcterms:modified>
  <cp:revision>2</cp:revision>
  <dc:subject/>
  <dc:title>Diapositive 1</dc:title>
</cp:coreProperties>
</file>